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88" d="100"/>
          <a:sy n="88" d="100"/>
        </p:scale>
        <p:origin x="3630" y="9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7E18FC-BA7B-4B69-8E50-0129C5B9120D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51F4E8-168F-42D7-AED4-7FC1DD3899B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912783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7E18FC-BA7B-4B69-8E50-0129C5B9120D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51F4E8-168F-42D7-AED4-7FC1DD3899B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362214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7E18FC-BA7B-4B69-8E50-0129C5B9120D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51F4E8-168F-42D7-AED4-7FC1DD3899B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440131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7E18FC-BA7B-4B69-8E50-0129C5B9120D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51F4E8-168F-42D7-AED4-7FC1DD3899B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833042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7E18FC-BA7B-4B69-8E50-0129C5B9120D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51F4E8-168F-42D7-AED4-7FC1DD3899B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479356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7E18FC-BA7B-4B69-8E50-0129C5B9120D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51F4E8-168F-42D7-AED4-7FC1DD3899B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93668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7E18FC-BA7B-4B69-8E50-0129C5B9120D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51F4E8-168F-42D7-AED4-7FC1DD3899B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354688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7E18FC-BA7B-4B69-8E50-0129C5B9120D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51F4E8-168F-42D7-AED4-7FC1DD3899B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709979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7E18FC-BA7B-4B69-8E50-0129C5B9120D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51F4E8-168F-42D7-AED4-7FC1DD3899B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926864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7E18FC-BA7B-4B69-8E50-0129C5B9120D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51F4E8-168F-42D7-AED4-7FC1DD3899B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613319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7E18FC-BA7B-4B69-8E50-0129C5B9120D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51F4E8-168F-42D7-AED4-7FC1DD3899B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606628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7E18FC-BA7B-4B69-8E50-0129C5B9120D}" type="datetimeFigureOut">
              <a:rPr lang="en-GB" smtClean="0"/>
              <a:t>20/0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51F4E8-168F-42D7-AED4-7FC1DD3899B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099853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1668860"/>
            <a:ext cx="148149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i="1" dirty="0" smtClean="0">
                <a:latin typeface="Times New Roman" pitchFamily="18" charset="0"/>
                <a:cs typeface="Times New Roman" pitchFamily="18" charset="0"/>
              </a:rPr>
              <a:t>Glyburide vs. insulin</a:t>
            </a:r>
            <a:endParaRPr lang="en-GB" sz="12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-19740" y="1029050"/>
            <a:ext cx="337464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S1 Fig Leave-one-criteria out analysis: birth weight</a:t>
            </a:r>
            <a:endParaRPr lang="en-GB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-8363" y="4162236"/>
            <a:ext cx="15247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i="1" dirty="0" smtClean="0">
                <a:latin typeface="Times New Roman" pitchFamily="18" charset="0"/>
                <a:cs typeface="Times New Roman" pitchFamily="18" charset="0"/>
              </a:rPr>
              <a:t>Metformin vs. insulin</a:t>
            </a:r>
            <a:endParaRPr lang="en-GB" sz="12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19865" y="6649199"/>
            <a:ext cx="16706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i="1" dirty="0" smtClean="0">
                <a:latin typeface="Times New Roman" pitchFamily="18" charset="0"/>
                <a:cs typeface="Times New Roman" pitchFamily="18" charset="0"/>
              </a:rPr>
              <a:t>Metformin vs. glyburide</a:t>
            </a:r>
            <a:endParaRPr lang="en-GB" sz="1200" i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5725" y="4501345"/>
            <a:ext cx="6772275" cy="19240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863" y="2267744"/>
            <a:ext cx="6772275" cy="1619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262" y="7020272"/>
            <a:ext cx="6772275" cy="12573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5440811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62</TotalTime>
  <Words>20</Words>
  <Application>Microsoft Office PowerPoint</Application>
  <PresentationFormat>On-screen Show (4:3)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indows User</dc:creator>
  <cp:lastModifiedBy>Jane Adkins</cp:lastModifiedBy>
  <cp:revision>24</cp:revision>
  <cp:lastPrinted>2019-07-30T07:45:45Z</cp:lastPrinted>
  <dcterms:created xsi:type="dcterms:W3CDTF">2019-06-26T12:19:39Z</dcterms:created>
  <dcterms:modified xsi:type="dcterms:W3CDTF">2020-02-20T07:53:58Z</dcterms:modified>
</cp:coreProperties>
</file>